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3060700" cy="3060700"/>
  <p:notesSz cx="6858000" cy="9144000"/>
  <p:defaultTextStyle>
    <a:defPPr>
      <a:defRPr lang="fr-FR"/>
    </a:defPPr>
    <a:lvl1pPr marL="0" algn="l" defTabSz="293797" rtl="0" eaLnBrk="1" latinLnBrk="0" hangingPunct="1">
      <a:defRPr sz="578" kern="1200">
        <a:solidFill>
          <a:schemeClr val="tx1"/>
        </a:solidFill>
        <a:latin typeface="+mn-lt"/>
        <a:ea typeface="+mn-ea"/>
        <a:cs typeface="+mn-cs"/>
      </a:defRPr>
    </a:lvl1pPr>
    <a:lvl2pPr marL="146898" algn="l" defTabSz="293797" rtl="0" eaLnBrk="1" latinLnBrk="0" hangingPunct="1">
      <a:defRPr sz="578" kern="1200">
        <a:solidFill>
          <a:schemeClr val="tx1"/>
        </a:solidFill>
        <a:latin typeface="+mn-lt"/>
        <a:ea typeface="+mn-ea"/>
        <a:cs typeface="+mn-cs"/>
      </a:defRPr>
    </a:lvl2pPr>
    <a:lvl3pPr marL="293797" algn="l" defTabSz="293797" rtl="0" eaLnBrk="1" latinLnBrk="0" hangingPunct="1">
      <a:defRPr sz="578" kern="1200">
        <a:solidFill>
          <a:schemeClr val="tx1"/>
        </a:solidFill>
        <a:latin typeface="+mn-lt"/>
        <a:ea typeface="+mn-ea"/>
        <a:cs typeface="+mn-cs"/>
      </a:defRPr>
    </a:lvl3pPr>
    <a:lvl4pPr marL="440695" algn="l" defTabSz="293797" rtl="0" eaLnBrk="1" latinLnBrk="0" hangingPunct="1">
      <a:defRPr sz="578" kern="1200">
        <a:solidFill>
          <a:schemeClr val="tx1"/>
        </a:solidFill>
        <a:latin typeface="+mn-lt"/>
        <a:ea typeface="+mn-ea"/>
        <a:cs typeface="+mn-cs"/>
      </a:defRPr>
    </a:lvl4pPr>
    <a:lvl5pPr marL="587593" algn="l" defTabSz="293797" rtl="0" eaLnBrk="1" latinLnBrk="0" hangingPunct="1">
      <a:defRPr sz="578" kern="1200">
        <a:solidFill>
          <a:schemeClr val="tx1"/>
        </a:solidFill>
        <a:latin typeface="+mn-lt"/>
        <a:ea typeface="+mn-ea"/>
        <a:cs typeface="+mn-cs"/>
      </a:defRPr>
    </a:lvl5pPr>
    <a:lvl6pPr marL="734492" algn="l" defTabSz="293797" rtl="0" eaLnBrk="1" latinLnBrk="0" hangingPunct="1">
      <a:defRPr sz="578" kern="1200">
        <a:solidFill>
          <a:schemeClr val="tx1"/>
        </a:solidFill>
        <a:latin typeface="+mn-lt"/>
        <a:ea typeface="+mn-ea"/>
        <a:cs typeface="+mn-cs"/>
      </a:defRPr>
    </a:lvl6pPr>
    <a:lvl7pPr marL="881390" algn="l" defTabSz="293797" rtl="0" eaLnBrk="1" latinLnBrk="0" hangingPunct="1">
      <a:defRPr sz="578" kern="1200">
        <a:solidFill>
          <a:schemeClr val="tx1"/>
        </a:solidFill>
        <a:latin typeface="+mn-lt"/>
        <a:ea typeface="+mn-ea"/>
        <a:cs typeface="+mn-cs"/>
      </a:defRPr>
    </a:lvl7pPr>
    <a:lvl8pPr marL="1028289" algn="l" defTabSz="293797" rtl="0" eaLnBrk="1" latinLnBrk="0" hangingPunct="1">
      <a:defRPr sz="578" kern="1200">
        <a:solidFill>
          <a:schemeClr val="tx1"/>
        </a:solidFill>
        <a:latin typeface="+mn-lt"/>
        <a:ea typeface="+mn-ea"/>
        <a:cs typeface="+mn-cs"/>
      </a:defRPr>
    </a:lvl8pPr>
    <a:lvl9pPr marL="1175187" algn="l" defTabSz="293797" rtl="0" eaLnBrk="1" latinLnBrk="0" hangingPunct="1">
      <a:defRPr sz="57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55" autoAdjust="0"/>
    <p:restoredTop sz="94660"/>
  </p:normalViewPr>
  <p:slideViewPr>
    <p:cSldViewPr snapToGrid="0">
      <p:cViewPr varScale="1">
        <p:scale>
          <a:sx n="175" d="100"/>
          <a:sy n="175" d="100"/>
        </p:scale>
        <p:origin x="132" y="6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9553" y="500906"/>
            <a:ext cx="2601595" cy="1065577"/>
          </a:xfrm>
        </p:spPr>
        <p:txBody>
          <a:bodyPr anchor="b"/>
          <a:lstStyle>
            <a:lvl1pPr algn="ctr">
              <a:defRPr sz="2008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2588" y="1607576"/>
            <a:ext cx="2295525" cy="738960"/>
          </a:xfrm>
        </p:spPr>
        <p:txBody>
          <a:bodyPr/>
          <a:lstStyle>
            <a:lvl1pPr marL="0" indent="0" algn="ctr">
              <a:buNone/>
              <a:defRPr sz="803"/>
            </a:lvl1pPr>
            <a:lvl2pPr marL="153025" indent="0" algn="ctr">
              <a:buNone/>
              <a:defRPr sz="669"/>
            </a:lvl2pPr>
            <a:lvl3pPr marL="306050" indent="0" algn="ctr">
              <a:buNone/>
              <a:defRPr sz="602"/>
            </a:lvl3pPr>
            <a:lvl4pPr marL="459075" indent="0" algn="ctr">
              <a:buNone/>
              <a:defRPr sz="536"/>
            </a:lvl4pPr>
            <a:lvl5pPr marL="612099" indent="0" algn="ctr">
              <a:buNone/>
              <a:defRPr sz="536"/>
            </a:lvl5pPr>
            <a:lvl6pPr marL="765124" indent="0" algn="ctr">
              <a:buNone/>
              <a:defRPr sz="536"/>
            </a:lvl6pPr>
            <a:lvl7pPr marL="918149" indent="0" algn="ctr">
              <a:buNone/>
              <a:defRPr sz="536"/>
            </a:lvl7pPr>
            <a:lvl8pPr marL="1071174" indent="0" algn="ctr">
              <a:buNone/>
              <a:defRPr sz="536"/>
            </a:lvl8pPr>
            <a:lvl9pPr marL="1224199" indent="0" algn="ctr">
              <a:buNone/>
              <a:defRPr sz="536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270457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12010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90314" y="162954"/>
            <a:ext cx="659963" cy="2593802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0423" y="162954"/>
            <a:ext cx="1941632" cy="2593802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825299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28234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829" y="763050"/>
            <a:ext cx="2639854" cy="1273166"/>
          </a:xfrm>
        </p:spPr>
        <p:txBody>
          <a:bodyPr anchor="b"/>
          <a:lstStyle>
            <a:lvl1pPr>
              <a:defRPr sz="2008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829" y="2048261"/>
            <a:ext cx="2639854" cy="669528"/>
          </a:xfrm>
        </p:spPr>
        <p:txBody>
          <a:bodyPr/>
          <a:lstStyle>
            <a:lvl1pPr marL="0" indent="0">
              <a:buNone/>
              <a:defRPr sz="803">
                <a:solidFill>
                  <a:schemeClr val="tx1"/>
                </a:solidFill>
              </a:defRPr>
            </a:lvl1pPr>
            <a:lvl2pPr marL="153025" indent="0">
              <a:buNone/>
              <a:defRPr sz="669">
                <a:solidFill>
                  <a:schemeClr val="tx1">
                    <a:tint val="75000"/>
                  </a:schemeClr>
                </a:solidFill>
              </a:defRPr>
            </a:lvl2pPr>
            <a:lvl3pPr marL="306050" indent="0">
              <a:buNone/>
              <a:defRPr sz="602">
                <a:solidFill>
                  <a:schemeClr val="tx1">
                    <a:tint val="75000"/>
                  </a:schemeClr>
                </a:solidFill>
              </a:defRPr>
            </a:lvl3pPr>
            <a:lvl4pPr marL="459075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4pPr>
            <a:lvl5pPr marL="6120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5pPr>
            <a:lvl6pPr marL="76512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6pPr>
            <a:lvl7pPr marL="91814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7pPr>
            <a:lvl8pPr marL="107117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8pPr>
            <a:lvl9pPr marL="12241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521779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0423" y="814770"/>
            <a:ext cx="1300798" cy="194198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49479" y="814770"/>
            <a:ext cx="1300798" cy="194198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26138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162955"/>
            <a:ext cx="2639854" cy="591594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822" y="750297"/>
            <a:ext cx="1294819" cy="367709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0822" y="1118006"/>
            <a:ext cx="1294819" cy="164441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49480" y="750297"/>
            <a:ext cx="1301196" cy="367709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49480" y="1118006"/>
            <a:ext cx="1301196" cy="164441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748089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650245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688236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204047"/>
            <a:ext cx="987155" cy="714163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01196" y="440685"/>
            <a:ext cx="1549479" cy="2175081"/>
          </a:xfrm>
        </p:spPr>
        <p:txBody>
          <a:bodyPr/>
          <a:lstStyle>
            <a:lvl1pPr>
              <a:defRPr sz="1071"/>
            </a:lvl1pPr>
            <a:lvl2pPr>
              <a:defRPr sz="937"/>
            </a:lvl2pPr>
            <a:lvl3pPr>
              <a:defRPr sz="803"/>
            </a:lvl3pPr>
            <a:lvl4pPr>
              <a:defRPr sz="669"/>
            </a:lvl4pPr>
            <a:lvl5pPr>
              <a:defRPr sz="669"/>
            </a:lvl5pPr>
            <a:lvl6pPr>
              <a:defRPr sz="669"/>
            </a:lvl6pPr>
            <a:lvl7pPr>
              <a:defRPr sz="669"/>
            </a:lvl7pPr>
            <a:lvl8pPr>
              <a:defRPr sz="669"/>
            </a:lvl8pPr>
            <a:lvl9pPr>
              <a:defRPr sz="669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918210"/>
            <a:ext cx="987155" cy="1701098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52631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204047"/>
            <a:ext cx="987155" cy="714163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01196" y="440685"/>
            <a:ext cx="1549479" cy="2175081"/>
          </a:xfrm>
        </p:spPr>
        <p:txBody>
          <a:bodyPr anchor="t"/>
          <a:lstStyle>
            <a:lvl1pPr marL="0" indent="0">
              <a:buNone/>
              <a:defRPr sz="1071"/>
            </a:lvl1pPr>
            <a:lvl2pPr marL="153025" indent="0">
              <a:buNone/>
              <a:defRPr sz="937"/>
            </a:lvl2pPr>
            <a:lvl3pPr marL="306050" indent="0">
              <a:buNone/>
              <a:defRPr sz="803"/>
            </a:lvl3pPr>
            <a:lvl4pPr marL="459075" indent="0">
              <a:buNone/>
              <a:defRPr sz="669"/>
            </a:lvl4pPr>
            <a:lvl5pPr marL="612099" indent="0">
              <a:buNone/>
              <a:defRPr sz="669"/>
            </a:lvl5pPr>
            <a:lvl6pPr marL="765124" indent="0">
              <a:buNone/>
              <a:defRPr sz="669"/>
            </a:lvl6pPr>
            <a:lvl7pPr marL="918149" indent="0">
              <a:buNone/>
              <a:defRPr sz="669"/>
            </a:lvl7pPr>
            <a:lvl8pPr marL="1071174" indent="0">
              <a:buNone/>
              <a:defRPr sz="669"/>
            </a:lvl8pPr>
            <a:lvl9pPr marL="1224199" indent="0">
              <a:buNone/>
              <a:defRPr sz="669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918210"/>
            <a:ext cx="987155" cy="1701098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408231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0423" y="162955"/>
            <a:ext cx="2639854" cy="5915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423" y="814770"/>
            <a:ext cx="2639854" cy="19419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0423" y="2836816"/>
            <a:ext cx="688658" cy="1629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963648-91CA-42A6-8209-8CEF68CC7E0E}" type="datetimeFigureOut">
              <a:rPr lang="fr-BE" smtClean="0"/>
              <a:t>23/09/2013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13857" y="2836816"/>
            <a:ext cx="1032986" cy="1629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61619" y="2836816"/>
            <a:ext cx="688658" cy="1629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4E4075-8FBF-4B84-96B1-6A20D65AB50C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50842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06050" rtl="0" eaLnBrk="1" latinLnBrk="0" hangingPunct="1">
        <a:lnSpc>
          <a:spcPct val="90000"/>
        </a:lnSpc>
        <a:spcBef>
          <a:spcPct val="0"/>
        </a:spcBef>
        <a:buNone/>
        <a:defRPr sz="14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6512" indent="-76512" algn="l" defTabSz="306050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937" kern="1200">
          <a:solidFill>
            <a:schemeClr val="tx1"/>
          </a:solidFill>
          <a:latin typeface="+mn-lt"/>
          <a:ea typeface="+mn-ea"/>
          <a:cs typeface="+mn-cs"/>
        </a:defRPr>
      </a:lvl1pPr>
      <a:lvl2pPr marL="2295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803" kern="1200">
          <a:solidFill>
            <a:schemeClr val="tx1"/>
          </a:solidFill>
          <a:latin typeface="+mn-lt"/>
          <a:ea typeface="+mn-ea"/>
          <a:cs typeface="+mn-cs"/>
        </a:defRPr>
      </a:lvl2pPr>
      <a:lvl3pPr marL="38256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69" kern="1200">
          <a:solidFill>
            <a:schemeClr val="tx1"/>
          </a:solidFill>
          <a:latin typeface="+mn-lt"/>
          <a:ea typeface="+mn-ea"/>
          <a:cs typeface="+mn-cs"/>
        </a:defRPr>
      </a:lvl3pPr>
      <a:lvl4pPr marL="53558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8861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8416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9466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147686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30071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1pPr>
      <a:lvl2pPr marL="153025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2pPr>
      <a:lvl3pPr marL="306050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3pPr>
      <a:lvl4pPr marL="459075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1209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765124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1814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071174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22419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38"/>
          <p:cNvSpPr/>
          <p:nvPr/>
        </p:nvSpPr>
        <p:spPr>
          <a:xfrm>
            <a:off x="89012" y="89012"/>
            <a:ext cx="2884811" cy="288076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69" y="551557"/>
            <a:ext cx="2564750" cy="195567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661463" y="479840"/>
            <a:ext cx="1859805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tivity measurement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 rot="16200000">
            <a:off x="-443381" y="1388867"/>
            <a:ext cx="1516762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nmolcitrulline.min</a:t>
            </a: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mgprot</a:t>
            </a:r>
            <a:r>
              <a:rPr lang="en-US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922709" y="2390069"/>
            <a:ext cx="1324402" cy="21544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ime of induction (hours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930064" y="2272500"/>
            <a:ext cx="57708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276471" y="2272500"/>
            <a:ext cx="57708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623557" y="2272500"/>
            <a:ext cx="57708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1969439" y="2272500"/>
            <a:ext cx="57708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317702" y="2272500"/>
            <a:ext cx="57708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2663287" y="2272500"/>
            <a:ext cx="57708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558424" y="1986751"/>
            <a:ext cx="57708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558424" y="1775903"/>
            <a:ext cx="57708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500716" y="1562906"/>
            <a:ext cx="115416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500716" y="1349448"/>
            <a:ext cx="115416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500716" y="1137526"/>
            <a:ext cx="115416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500716" y="923223"/>
            <a:ext cx="115416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00716" y="710846"/>
            <a:ext cx="115416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73177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27</Words>
  <Application>Microsoft Office PowerPoint</Application>
  <PresentationFormat>Personnalisé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Debailleul</dc:creator>
  <cp:lastModifiedBy>Fabien Debailleul</cp:lastModifiedBy>
  <cp:revision>9</cp:revision>
  <dcterms:created xsi:type="dcterms:W3CDTF">2013-05-07T11:24:59Z</dcterms:created>
  <dcterms:modified xsi:type="dcterms:W3CDTF">2013-09-23T14:20:17Z</dcterms:modified>
</cp:coreProperties>
</file>